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105" d="100"/>
          <a:sy n="105" d="100"/>
        </p:scale>
        <p:origin x="83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4939FA-DD8E-278F-A994-31C61B1CEF9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A917591-BAC0-240C-9A95-D4DDC7C9D9C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AD03392-9023-60FC-5BE1-E072843F2A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0AF660-D67F-40D8-88E8-2F3375029465}" type="datetimeFigureOut">
              <a:rPr lang="en-US" smtClean="0"/>
              <a:t>1/30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5581EF6-5271-0608-756F-21DDAD4F05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598902D-76CD-AF13-05ED-50F0153740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F8FE6-1B21-4FBF-8C03-EC36D568BC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62645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451D43A-EF52-2FD2-2614-4F626E89EBD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A2922B4-A9D3-6B71-BAB0-5050F55EA88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245D20F-7412-9FCA-3977-77F61F2B78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0AF660-D67F-40D8-88E8-2F3375029465}" type="datetimeFigureOut">
              <a:rPr lang="en-US" smtClean="0"/>
              <a:t>1/30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6437EA4-9D62-BBCA-5F74-3DDF9C871D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42A8260-9DCB-D24F-B3FA-7EA1D31220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F8FE6-1B21-4FBF-8C03-EC36D568BC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69576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80EBACA-46F8-77F7-80DF-D6334ED6D5D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4FE675C-ADDC-643C-E809-400F52DCA85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8142AF7-C273-D2F0-CE70-3DFE4DE8E7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0AF660-D67F-40D8-88E8-2F3375029465}" type="datetimeFigureOut">
              <a:rPr lang="en-US" smtClean="0"/>
              <a:t>1/30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B075F15-E49E-9653-D5EC-18AAAABD89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A7D3C84-5165-0EDC-C300-DC3077A3AF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F8FE6-1B21-4FBF-8C03-EC36D568BC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47506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9FB582-6484-577D-03DC-B42C340CDF1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9878FE9-E523-8E32-7C3B-E05312D1CD8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65B438A-3E07-BBBF-0CD0-3C2495AABC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0AF660-D67F-40D8-88E8-2F3375029465}" type="datetimeFigureOut">
              <a:rPr lang="en-US" smtClean="0"/>
              <a:t>1/30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64FD6BA-209A-17A7-4E6A-940019203B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C596189-CB5D-CCE1-A167-BED4CE3F50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F8FE6-1B21-4FBF-8C03-EC36D568BC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74578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69F427-42EE-E3A9-A425-7A2B1CA4BD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D5FB2F8-BEF3-A352-32C6-BABA97876DD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AE14B57-1080-201B-C284-0D95808048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0AF660-D67F-40D8-88E8-2F3375029465}" type="datetimeFigureOut">
              <a:rPr lang="en-US" smtClean="0"/>
              <a:t>1/30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C6A6D9F-BC59-09EB-30D2-975C2519A2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32C29A5-5AD5-0459-205B-0FADABB3FB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F8FE6-1B21-4FBF-8C03-EC36D568BC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80755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01527D-81D7-F0E1-9FD0-1F1A67FB599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30FF916-D31D-352C-F954-F3A111C06ED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DC4B67A-8A22-273D-E3FD-E14E8CA203C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0951A96-2709-1D68-C422-119D9F13A2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0AF660-D67F-40D8-88E8-2F3375029465}" type="datetimeFigureOut">
              <a:rPr lang="en-US" smtClean="0"/>
              <a:t>1/30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91D1239-3533-E40F-4AA2-09124A66B9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1AC6FC4-90A2-16AB-0DF3-DBF59483C4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F8FE6-1B21-4FBF-8C03-EC36D568BC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1334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69BC96-7D61-9E2B-4BFF-46386046A3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F06DDD0-4D20-E33D-29FE-9BEE6E7A37F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FBE7F88-5958-9AFB-74A4-83AB25F90C2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48A6DA8-DBCA-744B-EC63-7A083E65C9B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6D7B403-A19C-ABA8-2042-B1A3CD35D3A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89F39EF-69DC-6756-3D21-BF311C61B4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0AF660-D67F-40D8-88E8-2F3375029465}" type="datetimeFigureOut">
              <a:rPr lang="en-US" smtClean="0"/>
              <a:t>1/30/2026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172996C-C468-8D84-E9C9-DA1778B834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B6E5F27-F125-7A2E-0605-E1725290B6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F8FE6-1B21-4FBF-8C03-EC36D568BC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5542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2D5FAF-C1A1-30D9-7477-8F1C5F0774E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36C9801-F97B-BDF4-70DC-802FC8B522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0AF660-D67F-40D8-88E8-2F3375029465}" type="datetimeFigureOut">
              <a:rPr lang="en-US" smtClean="0"/>
              <a:t>1/30/2026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31331B7-46A3-E1E4-8E15-227D9BCF5D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D11161A-BDE0-2624-2A1A-A0CAB97FB7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F8FE6-1B21-4FBF-8C03-EC36D568BC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61379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B80436E-4A4B-06C2-83A3-EB3D664D3D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0AF660-D67F-40D8-88E8-2F3375029465}" type="datetimeFigureOut">
              <a:rPr lang="en-US" smtClean="0"/>
              <a:t>1/30/2026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2BADFB1-D311-BE96-D28F-50D6445CA0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4F480F5-0164-F0BC-A723-DE89F98CA4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F8FE6-1B21-4FBF-8C03-EC36D568BC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24429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56AD4E7-CF16-87C8-6572-C8BAD92E90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4EFE845-A002-3EB0-8EE9-81437BF3CE7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B9DBD4C-E5C9-2CAC-7869-0EA843D1A3B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4631196-E8B0-C549-8071-1293967495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0AF660-D67F-40D8-88E8-2F3375029465}" type="datetimeFigureOut">
              <a:rPr lang="en-US" smtClean="0"/>
              <a:t>1/30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DA99A5F-3749-3DD7-1CFB-A336EB039B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FBA37F3-953B-2AFD-0ABE-C749BA7729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F8FE6-1B21-4FBF-8C03-EC36D568BC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05291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92E5B7-4511-4ADB-7F68-9DC4CDD7D1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180E84C-751A-63DC-610F-FA13023EA56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96F51C0-7110-4211-232A-F5479123655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DFB6013-6C44-2B34-43F2-17904D6529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0AF660-D67F-40D8-88E8-2F3375029465}" type="datetimeFigureOut">
              <a:rPr lang="en-US" smtClean="0"/>
              <a:t>1/30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53A973D-D094-0EA1-4B5E-C94087635B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6AC3C3E-6C1B-7BFC-CED9-E4EEEB5919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F8FE6-1B21-4FBF-8C03-EC36D568BC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37618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CD10BE3-EDC7-16F7-DBE4-0BD1EDC698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096DFD4-FC7D-41F6-C8C2-93501C18F64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9AC1C72-D08F-4370-7756-729D4F76ECC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B0AF660-D67F-40D8-88E8-2F3375029465}" type="datetimeFigureOut">
              <a:rPr lang="en-US" smtClean="0"/>
              <a:t>1/30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31C1421-D3B0-DEF2-A89A-956303AEA9E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0B96FD2-F413-5651-80CE-6049C9C3335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F6F8FE6-1B21-4FBF-8C03-EC36D568BC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04941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graph of a lead time&#10;&#10;AI-generated content may be incorrect.">
            <a:extLst>
              <a:ext uri="{FF2B5EF4-FFF2-40B4-BE49-F238E27FC236}">
                <a16:creationId xmlns:a16="http://schemas.microsoft.com/office/drawing/2014/main" id="{957C934B-9874-5E82-F7DA-E1422945FA6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08476" y="307848"/>
            <a:ext cx="4575048" cy="624230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0405737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346EE3CD-C625-4BE6-905F-80DBE7FEA466}"/>
              </a:ext>
            </a:extLst>
          </p:cNvPr>
          <p:cNvSpPr txBox="1"/>
          <p:nvPr/>
        </p:nvSpPr>
        <p:spPr>
          <a:xfrm>
            <a:off x="3048000" y="2122168"/>
            <a:ext cx="6096000" cy="2613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15000"/>
              </a:lnSpc>
              <a:buNone/>
            </a:pPr>
            <a:r>
              <a:rPr lang="en-US" sz="1800" b="1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Supplementary Figure 7</a:t>
            </a:r>
            <a:r>
              <a:rPr lang="en-US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. Distribution of lead time between ctDNA detection and imaging-confirmed recurrence using the first ctDNA-positive sample prior to recurrence. Each dot represents an individual patient with green dots representing patients who became ctDNA-positive and whose initial post-positivity imaging remained negative with recurrence confirmed on subsequent imaging.  </a:t>
            </a:r>
          </a:p>
        </p:txBody>
      </p:sp>
    </p:spTree>
    <p:extLst>
      <p:ext uri="{BB962C8B-B14F-4D97-AF65-F5344CB8AC3E}">
        <p14:creationId xmlns:p14="http://schemas.microsoft.com/office/powerpoint/2010/main" val="4284322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1</Words>
  <Application>Microsoft Office PowerPoint</Application>
  <PresentationFormat>Widescreen</PresentationFormat>
  <Paragraphs>1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ptos</vt:lpstr>
      <vt:lpstr>Aptos Display</vt:lpstr>
      <vt:lpstr>Arial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iegmann, Bill</dc:creator>
  <cp:lastModifiedBy>Siegmann, Bill</cp:lastModifiedBy>
  <cp:revision>1</cp:revision>
  <dcterms:created xsi:type="dcterms:W3CDTF">2026-01-30T20:15:32Z</dcterms:created>
  <dcterms:modified xsi:type="dcterms:W3CDTF">2026-01-30T20:16:02Z</dcterms:modified>
</cp:coreProperties>
</file>